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40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D392B7-DDFB-94FF-0D56-0058A3EB82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8D543CD-323D-FA7B-AF27-4139532858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1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4" indent="0" algn="ctr">
              <a:buNone/>
              <a:defRPr sz="1600"/>
            </a:lvl5pPr>
            <a:lvl6pPr marL="2285904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7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F0B67A-7CC4-9717-80C1-664E25F22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3526E7-5CC6-4B8E-816A-4C4399823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885B79-E206-E188-3CEB-53679339C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27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98B54A-5AFB-401C-1593-3C6610C695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336E824-CC4D-7494-BA11-F9370764E8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EED4E1-9306-0BF6-3AF4-CE447B076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E1A929-5511-BAC8-EFEE-7FC69C3F9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8F352B-F924-0F37-129B-66B55D1E2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6546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966264D-FD9D-9574-DEA7-531125496F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AEA2377-C21F-5457-9ADF-4B473F7B41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329825-76E6-3F79-E839-81E65FA41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9CF7DE-D3C2-9F37-12F6-0009AFAA6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C27E96-911F-39D3-CC63-71841A4C6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360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BDC07E-B025-8D9C-A9BD-D554BF7F9A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C53901-2A7B-9D92-6C77-07338412E2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2E644C-C8A7-812B-5A5E-BEF1A214B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8CE1D8-CE8F-361D-E81E-3362B742B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FD5404-ADC7-1188-1FC5-FA2788BAD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9688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1AF1E8-F1D7-F207-E35B-5635BEC4C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BE8867-3330-6E64-A6D2-080C26F21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F6EB4E-FDDB-3901-5267-96E18BE50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840C38-712E-0D55-8F12-943BFEFB4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015811-BB47-23AF-FAF7-378931818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218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1F60CB-219C-59E6-73B0-BFE50C544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0870ED-A398-7FE3-4542-FA8FF43598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98F606-9581-CF12-340A-8286A6AE0A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2A2A67-9B76-0E60-59F1-865DEB434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EB7BFE-4A58-F39A-E791-FEAE7D5F9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899046-D20E-A574-EB07-1EC8774D7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504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600E37-49DA-27B9-1F89-4357F1CACB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CE4F4D-B369-D164-8769-46304644C4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78EC361-FBA0-E0A0-A924-9BCD68C865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51EBF85-9CC7-4603-D904-2E05E81A27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D53AB4B-7DE3-20EB-C65E-27ED3B7AD6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50202D8-A11F-54DE-C059-6A18F0E0C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1B3A3F9-5F78-8C5E-95C4-14D8E0241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E311B62-2865-E96B-EF48-EE7E7ECA5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2555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128700-4069-3C18-6024-8045A2C4A1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7289366-1426-053C-7E20-D7345EA82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EC05E13-94BD-4626-DA25-E5E500F98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DA8C67D-F03B-3B1F-1558-53C6332C5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444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E29E297-5297-0566-D518-7E334DD60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1C8A2DD-4D6B-5F5B-6103-7364D1840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FEA7B08-951B-840E-1533-276D291B8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23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92B7AA-DD2F-2FCE-99CE-C41F6B6DF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B34C59-FB89-3972-AC94-28D280EAA3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D564AAB-62CE-760E-DE18-5931C16200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85D5B4-4145-E3E5-0E63-742D6A0E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128A0B-79C4-B19C-A4C5-96EED25DE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8D1243-29E5-E7B9-761C-631A67263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9127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D1C28F-5212-A150-1976-B6A56CA9D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3E42829-5566-FF51-4A80-C8C17B2132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228FD3C-4560-55BE-0774-30A9310BD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E0160CD-C398-6154-407C-8AE74A995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806170-6244-A54F-781C-D9AC4145E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3B141A-0ACD-28E5-FBC7-23896E39D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8246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01DB789-9546-E57B-0734-6D212A5A0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D3FD4A0-8BB4-848E-C0AD-7B3625BCF0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ADF6BC-7DD0-7DAC-D34E-9F41ADD598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FB61F-CDDB-4729-8D1D-F35FC8D6AD14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378377-6455-EF18-4A13-BDE1046132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E27B71-C766-DDFE-3D2F-337B2DBED6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A50C8-C694-4323-98B4-518B77B003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9712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37">
            <a:extLst>
              <a:ext uri="{FF2B5EF4-FFF2-40B4-BE49-F238E27FC236}">
                <a16:creationId xmlns:a16="http://schemas.microsoft.com/office/drawing/2014/main" id="{2851A42E-0EFD-C1D0-F9E9-B6C43CBD6A7E}"/>
              </a:ext>
            </a:extLst>
          </p:cNvPr>
          <p:cNvSpPr txBox="1"/>
          <p:nvPr/>
        </p:nvSpPr>
        <p:spPr>
          <a:xfrm>
            <a:off x="-5545" y="245551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F079318E-FAAD-5BC0-0264-425E8F009E9A}"/>
              </a:ext>
            </a:extLst>
          </p:cNvPr>
          <p:cNvGrpSpPr/>
          <p:nvPr/>
        </p:nvGrpSpPr>
        <p:grpSpPr>
          <a:xfrm>
            <a:off x="2840687" y="547992"/>
            <a:ext cx="4468184" cy="3064634"/>
            <a:chOff x="6057900" y="0"/>
            <a:chExt cx="4476858" cy="3010544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91D68C44-9232-A04A-4EB6-037ECDDD5E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57900" y="0"/>
              <a:ext cx="4476858" cy="2839567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A6A53AF-5845-B230-1776-ADAA2FD2D367}"/>
                </a:ext>
              </a:extLst>
            </p:cNvPr>
            <p:cNvSpPr txBox="1"/>
            <p:nvPr/>
          </p:nvSpPr>
          <p:spPr>
            <a:xfrm>
              <a:off x="7163225" y="2637816"/>
              <a:ext cx="2750389" cy="37272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ttp://www.mirdb.org/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文本框 37">
            <a:extLst>
              <a:ext uri="{FF2B5EF4-FFF2-40B4-BE49-F238E27FC236}">
                <a16:creationId xmlns:a16="http://schemas.microsoft.com/office/drawing/2014/main" id="{6AC7A9E1-6719-9BF5-F946-1E56E17EC2DA}"/>
              </a:ext>
            </a:extLst>
          </p:cNvPr>
          <p:cNvSpPr txBox="1"/>
          <p:nvPr/>
        </p:nvSpPr>
        <p:spPr>
          <a:xfrm>
            <a:off x="2725986" y="245551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BE525D46-BBD4-1900-6049-FB499D491794}"/>
              </a:ext>
            </a:extLst>
          </p:cNvPr>
          <p:cNvGrpSpPr/>
          <p:nvPr/>
        </p:nvGrpSpPr>
        <p:grpSpPr>
          <a:xfrm>
            <a:off x="7487938" y="547992"/>
            <a:ext cx="4656465" cy="3545832"/>
            <a:chOff x="6057900" y="3323385"/>
            <a:chExt cx="4940556" cy="3517697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087C8C36-989F-620D-60B9-924B19FB0B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091" r="7922"/>
            <a:stretch/>
          </p:blipFill>
          <p:spPr>
            <a:xfrm>
              <a:off x="6151889" y="3323385"/>
              <a:ext cx="4846567" cy="3135919"/>
            </a:xfrm>
            <a:prstGeom prst="rect">
              <a:avLst/>
            </a:prstGeom>
          </p:spPr>
        </p:pic>
        <p:sp>
          <p:nvSpPr>
            <p:cNvPr id="17" name="矩形: 圆角 16">
              <a:extLst>
                <a:ext uri="{FF2B5EF4-FFF2-40B4-BE49-F238E27FC236}">
                  <a16:creationId xmlns:a16="http://schemas.microsoft.com/office/drawing/2014/main" id="{5EB442B6-50BE-8398-2170-6C88915A87F4}"/>
                </a:ext>
              </a:extLst>
            </p:cNvPr>
            <p:cNvSpPr/>
            <p:nvPr/>
          </p:nvSpPr>
          <p:spPr>
            <a:xfrm>
              <a:off x="6057900" y="5983572"/>
              <a:ext cx="4898218" cy="191923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760041C6-E47B-9D67-D1A9-94D768C63F70}"/>
                </a:ext>
              </a:extLst>
            </p:cNvPr>
            <p:cNvSpPr txBox="1"/>
            <p:nvPr/>
          </p:nvSpPr>
          <p:spPr>
            <a:xfrm>
              <a:off x="6672285" y="6459304"/>
              <a:ext cx="4283834" cy="38177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http://mirwalk.umm.uni-heidelberg.de/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21956E72-CFC7-7E66-9212-C2A9FAAF9FD0}"/>
              </a:ext>
            </a:extLst>
          </p:cNvPr>
          <p:cNvSpPr txBox="1"/>
          <p:nvPr/>
        </p:nvSpPr>
        <p:spPr>
          <a:xfrm>
            <a:off x="9659529" y="58218"/>
            <a:ext cx="23797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37">
            <a:extLst>
              <a:ext uri="{FF2B5EF4-FFF2-40B4-BE49-F238E27FC236}">
                <a16:creationId xmlns:a16="http://schemas.microsoft.com/office/drawing/2014/main" id="{384164B5-ADD1-8869-430C-89CDFE6C8442}"/>
              </a:ext>
            </a:extLst>
          </p:cNvPr>
          <p:cNvSpPr txBox="1"/>
          <p:nvPr/>
        </p:nvSpPr>
        <p:spPr>
          <a:xfrm>
            <a:off x="7250588" y="24555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0E08470-BB60-5F30-F5CD-C282C489F4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23457" y="4435603"/>
            <a:ext cx="1168591" cy="141361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4B8C2AA-4EF1-F207-F1F9-E16C402758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17745" y="4457196"/>
            <a:ext cx="1170000" cy="142342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B69AB0D-E08C-333C-DF0A-F68E1820074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3873"/>
          <a:stretch/>
        </p:blipFill>
        <p:spPr>
          <a:xfrm>
            <a:off x="10257752" y="4430228"/>
            <a:ext cx="1781560" cy="1424368"/>
          </a:xfrm>
          <a:prstGeom prst="rect">
            <a:avLst/>
          </a:prstGeom>
        </p:spPr>
      </p:pic>
      <p:grpSp>
        <p:nvGrpSpPr>
          <p:cNvPr id="23" name="组合 22">
            <a:extLst>
              <a:ext uri="{FF2B5EF4-FFF2-40B4-BE49-F238E27FC236}">
                <a16:creationId xmlns:a16="http://schemas.microsoft.com/office/drawing/2014/main" id="{1F3CE58B-FA8D-B494-1A15-7F07D10272EF}"/>
              </a:ext>
            </a:extLst>
          </p:cNvPr>
          <p:cNvGrpSpPr/>
          <p:nvPr/>
        </p:nvGrpSpPr>
        <p:grpSpPr>
          <a:xfrm>
            <a:off x="42755" y="547992"/>
            <a:ext cx="2772741" cy="3485072"/>
            <a:chOff x="227243" y="1992754"/>
            <a:chExt cx="3902350" cy="5679328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9424C941-9EDC-6DAB-ABD4-D5AB220D9150}"/>
                </a:ext>
              </a:extLst>
            </p:cNvPr>
            <p:cNvGrpSpPr/>
            <p:nvPr/>
          </p:nvGrpSpPr>
          <p:grpSpPr>
            <a:xfrm>
              <a:off x="227243" y="1992754"/>
              <a:ext cx="3902350" cy="5422689"/>
              <a:chOff x="15383" y="-193864"/>
              <a:chExt cx="4769720" cy="662798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C92F2149-6CDF-A867-1E03-B8E1B9D9DA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12892" r="43223"/>
              <a:stretch/>
            </p:blipFill>
            <p:spPr>
              <a:xfrm>
                <a:off x="15383" y="-193864"/>
                <a:ext cx="4769720" cy="6627983"/>
              </a:xfrm>
              <a:prstGeom prst="rect">
                <a:avLst/>
              </a:prstGeom>
            </p:spPr>
          </p:pic>
          <p:sp>
            <p:nvSpPr>
              <p:cNvPr id="6" name="矩形: 圆角 5">
                <a:extLst>
                  <a:ext uri="{FF2B5EF4-FFF2-40B4-BE49-F238E27FC236}">
                    <a16:creationId xmlns:a16="http://schemas.microsoft.com/office/drawing/2014/main" id="{0CFDCBFB-5F4A-C4EC-2C2F-D6DCD5FCAE4D}"/>
                  </a:ext>
                </a:extLst>
              </p:cNvPr>
              <p:cNvSpPr/>
              <p:nvPr/>
            </p:nvSpPr>
            <p:spPr>
              <a:xfrm>
                <a:off x="112729" y="3973039"/>
                <a:ext cx="4546700" cy="286352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957B582-2982-699A-6478-1228A1AC3E31}"/>
                </a:ext>
              </a:extLst>
            </p:cNvPr>
            <p:cNvSpPr txBox="1"/>
            <p:nvPr/>
          </p:nvSpPr>
          <p:spPr>
            <a:xfrm>
              <a:off x="850247" y="7285541"/>
              <a:ext cx="2750389" cy="3865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ttp://www.mirdb.org/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文本框 37">
            <a:extLst>
              <a:ext uri="{FF2B5EF4-FFF2-40B4-BE49-F238E27FC236}">
                <a16:creationId xmlns:a16="http://schemas.microsoft.com/office/drawing/2014/main" id="{E5E8EA5E-D04C-0D7B-8E03-34A4F4CD6E6D}"/>
              </a:ext>
            </a:extLst>
          </p:cNvPr>
          <p:cNvSpPr txBox="1"/>
          <p:nvPr/>
        </p:nvSpPr>
        <p:spPr>
          <a:xfrm>
            <a:off x="-5545" y="398516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37">
            <a:extLst>
              <a:ext uri="{FF2B5EF4-FFF2-40B4-BE49-F238E27FC236}">
                <a16:creationId xmlns:a16="http://schemas.microsoft.com/office/drawing/2014/main" id="{2A139E4D-C3EE-E400-853F-58D3F76BF15E}"/>
              </a:ext>
            </a:extLst>
          </p:cNvPr>
          <p:cNvSpPr txBox="1"/>
          <p:nvPr/>
        </p:nvSpPr>
        <p:spPr>
          <a:xfrm>
            <a:off x="8853430" y="3985161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37">
            <a:extLst>
              <a:ext uri="{FF2B5EF4-FFF2-40B4-BE49-F238E27FC236}">
                <a16:creationId xmlns:a16="http://schemas.microsoft.com/office/drawing/2014/main" id="{776FB294-4267-A1D0-7A84-D5F117A1D3A5}"/>
              </a:ext>
            </a:extLst>
          </p:cNvPr>
          <p:cNvSpPr txBox="1"/>
          <p:nvPr/>
        </p:nvSpPr>
        <p:spPr>
          <a:xfrm>
            <a:off x="10072445" y="398516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1B73439A-9717-319C-D80F-840B19684E5A}"/>
              </a:ext>
            </a:extLst>
          </p:cNvPr>
          <p:cNvGrpSpPr/>
          <p:nvPr/>
        </p:nvGrpSpPr>
        <p:grpSpPr>
          <a:xfrm>
            <a:off x="20660" y="4356092"/>
            <a:ext cx="1949112" cy="1935328"/>
            <a:chOff x="-776555" y="4608782"/>
            <a:chExt cx="2095604" cy="2080784"/>
          </a:xfrm>
        </p:grpSpPr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DA1EAB72-F6EA-1B91-8977-58CD0701A6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262" t="3260" b="54826"/>
            <a:stretch/>
          </p:blipFill>
          <p:spPr>
            <a:xfrm>
              <a:off x="-776555" y="4785320"/>
              <a:ext cx="2095604" cy="1904246"/>
            </a:xfrm>
            <a:prstGeom prst="rect">
              <a:avLst/>
            </a:prstGeom>
          </p:spPr>
        </p:pic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2398587-79D8-144D-87CF-83969637EC23}"/>
                </a:ext>
              </a:extLst>
            </p:cNvPr>
            <p:cNvSpPr txBox="1"/>
            <p:nvPr/>
          </p:nvSpPr>
          <p:spPr>
            <a:xfrm>
              <a:off x="-274966" y="4608782"/>
              <a:ext cx="11448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irst-progressio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2D1F5D6D-41C6-3E4A-7D64-03C518C1135C}"/>
              </a:ext>
            </a:extLst>
          </p:cNvPr>
          <p:cNvGrpSpPr/>
          <p:nvPr/>
        </p:nvGrpSpPr>
        <p:grpSpPr>
          <a:xfrm>
            <a:off x="3923695" y="4281588"/>
            <a:ext cx="2034752" cy="2009832"/>
            <a:chOff x="3483656" y="4714901"/>
            <a:chExt cx="2187681" cy="2160887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7E6B94E2-6ECF-8FE7-111B-F12AA7316E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909" t="4999" b="54586"/>
            <a:stretch/>
          </p:blipFill>
          <p:spPr>
            <a:xfrm>
              <a:off x="3483656" y="4938319"/>
              <a:ext cx="2187681" cy="1937469"/>
            </a:xfrm>
            <a:prstGeom prst="rect">
              <a:avLst/>
            </a:prstGeom>
          </p:spPr>
        </p:pic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B56282DB-458C-DE74-B549-C4671B850D0A}"/>
                </a:ext>
              </a:extLst>
            </p:cNvPr>
            <p:cNvSpPr txBox="1"/>
            <p:nvPr/>
          </p:nvSpPr>
          <p:spPr>
            <a:xfrm>
              <a:off x="4043557" y="4714901"/>
              <a:ext cx="11496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-progressio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8C635B14-4A08-FB82-0CE4-0797CA781CDF}"/>
              </a:ext>
            </a:extLst>
          </p:cNvPr>
          <p:cNvGrpSpPr/>
          <p:nvPr/>
        </p:nvGrpSpPr>
        <p:grpSpPr>
          <a:xfrm>
            <a:off x="5894283" y="4320972"/>
            <a:ext cx="1911145" cy="1919042"/>
            <a:chOff x="5617475" y="4790681"/>
            <a:chExt cx="2054783" cy="2063274"/>
          </a:xfrm>
        </p:grpSpPr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729F57D9-E5E5-9F25-D8C5-EAB296EB6B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774" t="54586"/>
            <a:stretch/>
          </p:blipFill>
          <p:spPr>
            <a:xfrm>
              <a:off x="5617475" y="4790681"/>
              <a:ext cx="2054783" cy="2063274"/>
            </a:xfrm>
            <a:prstGeom prst="rect">
              <a:avLst/>
            </a:prstGeom>
          </p:spPr>
        </p:pic>
        <p:cxnSp>
          <p:nvCxnSpPr>
            <p:cNvPr id="35" name="直接箭头连接符 34">
              <a:extLst>
                <a:ext uri="{FF2B5EF4-FFF2-40B4-BE49-F238E27FC236}">
                  <a16:creationId xmlns:a16="http://schemas.microsoft.com/office/drawing/2014/main" id="{9D4A93AB-C39B-BB05-C9EF-1E27845267B9}"/>
                </a:ext>
              </a:extLst>
            </p:cNvPr>
            <p:cNvCxnSpPr/>
            <p:nvPr/>
          </p:nvCxnSpPr>
          <p:spPr>
            <a:xfrm>
              <a:off x="6224231" y="6198231"/>
              <a:ext cx="0" cy="26844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B78AE559-8C07-9143-D249-3335B3CB9A55}"/>
                </a:ext>
              </a:extLst>
            </p:cNvPr>
            <p:cNvSpPr txBox="1"/>
            <p:nvPr/>
          </p:nvSpPr>
          <p:spPr>
            <a:xfrm>
              <a:off x="5961046" y="5943327"/>
              <a:ext cx="5922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utoff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925D7269-2263-B0B4-E111-B3424AEAE439}"/>
              </a:ext>
            </a:extLst>
          </p:cNvPr>
          <p:cNvGrpSpPr/>
          <p:nvPr/>
        </p:nvGrpSpPr>
        <p:grpSpPr>
          <a:xfrm>
            <a:off x="1929161" y="4295036"/>
            <a:ext cx="1949112" cy="1982505"/>
            <a:chOff x="1369146" y="4675761"/>
            <a:chExt cx="2095604" cy="2131507"/>
          </a:xfrm>
        </p:grpSpPr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94B914E9-EC8A-5589-7634-665648AF97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262" t="53084"/>
            <a:stretch/>
          </p:blipFill>
          <p:spPr>
            <a:xfrm>
              <a:off x="1369146" y="4675761"/>
              <a:ext cx="2095604" cy="2131507"/>
            </a:xfrm>
            <a:prstGeom prst="rect">
              <a:avLst/>
            </a:prstGeom>
          </p:spPr>
        </p:pic>
        <p:cxnSp>
          <p:nvCxnSpPr>
            <p:cNvPr id="34" name="直接箭头连接符 33">
              <a:extLst>
                <a:ext uri="{FF2B5EF4-FFF2-40B4-BE49-F238E27FC236}">
                  <a16:creationId xmlns:a16="http://schemas.microsoft.com/office/drawing/2014/main" id="{FE7396DC-94E5-F2B9-AE9E-668A2F91800B}"/>
                </a:ext>
              </a:extLst>
            </p:cNvPr>
            <p:cNvCxnSpPr/>
            <p:nvPr/>
          </p:nvCxnSpPr>
          <p:spPr>
            <a:xfrm>
              <a:off x="1939283" y="6115544"/>
              <a:ext cx="0" cy="26844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5EA7B1AB-9C9F-D6C0-74C7-A84CE89BCE05}"/>
                </a:ext>
              </a:extLst>
            </p:cNvPr>
            <p:cNvSpPr txBox="1"/>
            <p:nvPr/>
          </p:nvSpPr>
          <p:spPr>
            <a:xfrm>
              <a:off x="1565146" y="5877368"/>
              <a:ext cx="5922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utoff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文本框 37">
            <a:extLst>
              <a:ext uri="{FF2B5EF4-FFF2-40B4-BE49-F238E27FC236}">
                <a16:creationId xmlns:a16="http://schemas.microsoft.com/office/drawing/2014/main" id="{80932FF2-8A0E-2A47-3550-E81B5C5B51F9}"/>
              </a:ext>
            </a:extLst>
          </p:cNvPr>
          <p:cNvSpPr txBox="1"/>
          <p:nvPr/>
        </p:nvSpPr>
        <p:spPr>
          <a:xfrm>
            <a:off x="3844033" y="3985161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37">
            <a:extLst>
              <a:ext uri="{FF2B5EF4-FFF2-40B4-BE49-F238E27FC236}">
                <a16:creationId xmlns:a16="http://schemas.microsoft.com/office/drawing/2014/main" id="{A631B055-6556-CC6C-C565-60ECE7FF683B}"/>
              </a:ext>
            </a:extLst>
          </p:cNvPr>
          <p:cNvSpPr txBox="1"/>
          <p:nvPr/>
        </p:nvSpPr>
        <p:spPr>
          <a:xfrm>
            <a:off x="7681332" y="3985161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173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50</TotalTime>
  <Words>46</Words>
  <Application>Microsoft Office PowerPoint</Application>
  <PresentationFormat>宽屏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XINYI</dc:creator>
  <cp:lastModifiedBy>XINYI MA</cp:lastModifiedBy>
  <cp:revision>34</cp:revision>
  <dcterms:created xsi:type="dcterms:W3CDTF">2023-08-13T04:48:51Z</dcterms:created>
  <dcterms:modified xsi:type="dcterms:W3CDTF">2023-12-11T07:27:08Z</dcterms:modified>
</cp:coreProperties>
</file>